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325" r:id="rId2"/>
    <p:sldId id="323" r:id="rId3"/>
    <p:sldId id="326" r:id="rId4"/>
    <p:sldId id="327" r:id="rId5"/>
    <p:sldId id="328" r:id="rId6"/>
    <p:sldId id="316" r:id="rId7"/>
  </p:sldIdLst>
  <p:sldSz cx="6675438" cy="8961438"/>
  <p:notesSz cx="7010400" cy="9296400"/>
  <p:defaultTextStyle>
    <a:defPPr>
      <a:defRPr lang="en-US"/>
    </a:defPPr>
    <a:lvl1pPr marL="0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1pPr>
    <a:lvl2pPr marL="375253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2pPr>
    <a:lvl3pPr marL="750504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3pPr>
    <a:lvl4pPr marL="1125756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4pPr>
    <a:lvl5pPr marL="1501008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5pPr>
    <a:lvl6pPr marL="1876260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6pPr>
    <a:lvl7pPr marL="2251513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7pPr>
    <a:lvl8pPr marL="2626764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8pPr>
    <a:lvl9pPr marL="3002016" algn="l" defTabSz="750504" rtl="0" eaLnBrk="1" latinLnBrk="0" hangingPunct="1">
      <a:defRPr sz="14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660"/>
  </p:normalViewPr>
  <p:slideViewPr>
    <p:cSldViewPr snapToGrid="0">
      <p:cViewPr varScale="1">
        <p:scale>
          <a:sx n="85" d="100"/>
          <a:sy n="85" d="100"/>
        </p:scale>
        <p:origin x="306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m2wz\Box\Projects\Jennie%20Ma\SEEM\BileAcid%20Xueheng\Results\Bileacid%20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m2wz\Box\Projects\Jennie%20Ma\SEEM\BileAcid%20Xueheng\Results\Bileacid%20resul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Data 101520'!$C$10</c:f>
              <c:strCache>
                <c:ptCount val="1"/>
                <c:pt idx="0">
                  <c:v>Variable importanc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Data 101520'!$B$11:$B$16</c:f>
              <c:strCache>
                <c:ptCount val="6"/>
                <c:pt idx="0">
                  <c:v>GUDCA</c:v>
                </c:pt>
                <c:pt idx="1">
                  <c:v>TDCA</c:v>
                </c:pt>
                <c:pt idx="2">
                  <c:v>GDCA</c:v>
                </c:pt>
                <c:pt idx="3">
                  <c:v>DCA</c:v>
                </c:pt>
                <c:pt idx="4">
                  <c:v>UDCA</c:v>
                </c:pt>
                <c:pt idx="5">
                  <c:v>TCA</c:v>
                </c:pt>
              </c:strCache>
            </c:strRef>
          </c:cat>
          <c:val>
            <c:numRef>
              <c:f>'Data 101520'!$C$11:$C$16</c:f>
              <c:numCache>
                <c:formatCode>0.000000</c:formatCode>
                <c:ptCount val="6"/>
                <c:pt idx="0">
                  <c:v>1.4454079999999999E-2</c:v>
                </c:pt>
                <c:pt idx="1">
                  <c:v>1.3482299999999999E-2</c:v>
                </c:pt>
                <c:pt idx="2">
                  <c:v>1.342144E-2</c:v>
                </c:pt>
                <c:pt idx="3">
                  <c:v>8.3102179999999999E-4</c:v>
                </c:pt>
                <c:pt idx="4">
                  <c:v>5.696516E-4</c:v>
                </c:pt>
                <c:pt idx="5">
                  <c:v>2.3939100000000001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205-4B53-AA73-D613FFE885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75339528"/>
        <c:axId val="275343840"/>
      </c:barChart>
      <c:catAx>
        <c:axId val="27533952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5343840"/>
        <c:crosses val="autoZero"/>
        <c:auto val="1"/>
        <c:lblAlgn val="ctr"/>
        <c:lblOffset val="100"/>
        <c:noMultiLvlLbl val="0"/>
      </c:catAx>
      <c:valAx>
        <c:axId val="2753438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Variable Import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5339528"/>
        <c:crosses val="max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Data 101520'!$R$10</c:f>
              <c:strCache>
                <c:ptCount val="1"/>
                <c:pt idx="0">
                  <c:v>Variable importanc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Data 101520'!$Q$11:$Q$15</c:f>
              <c:strCache>
                <c:ptCount val="5"/>
                <c:pt idx="0">
                  <c:v>GDCA</c:v>
                </c:pt>
                <c:pt idx="1">
                  <c:v>GUDCA</c:v>
                </c:pt>
                <c:pt idx="2">
                  <c:v>TDCA</c:v>
                </c:pt>
                <c:pt idx="3">
                  <c:v>DCA</c:v>
                </c:pt>
                <c:pt idx="4">
                  <c:v>TCA</c:v>
                </c:pt>
              </c:strCache>
            </c:strRef>
          </c:cat>
          <c:val>
            <c:numRef>
              <c:f>'Data 101520'!$R$11:$R$15</c:f>
              <c:numCache>
                <c:formatCode>0.000000</c:formatCode>
                <c:ptCount val="5"/>
                <c:pt idx="0">
                  <c:v>1.4953539599999999E-2</c:v>
                </c:pt>
                <c:pt idx="1">
                  <c:v>1.2483152900000001E-2</c:v>
                </c:pt>
                <c:pt idx="2">
                  <c:v>4.3528951999999999E-3</c:v>
                </c:pt>
                <c:pt idx="3">
                  <c:v>2.0774884999999999E-3</c:v>
                </c:pt>
                <c:pt idx="4">
                  <c:v>2.0029203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95D-45B2-8BE2-4161B1709E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75339920"/>
        <c:axId val="306334152"/>
      </c:barChart>
      <c:catAx>
        <c:axId val="27533992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6334152"/>
        <c:crosses val="autoZero"/>
        <c:auto val="1"/>
        <c:lblAlgn val="ctr"/>
        <c:lblOffset val="100"/>
        <c:noMultiLvlLbl val="0"/>
      </c:catAx>
      <c:valAx>
        <c:axId val="306334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Variable Import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5339920"/>
        <c:crosses val="max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E88742F-43C0-42AB-A8A4-4C27C7CA68D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62050"/>
            <a:ext cx="23368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8B41ED4-83B9-4D39-8D9A-F120F7B4E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126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1pPr>
    <a:lvl2pPr marL="375253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2pPr>
    <a:lvl3pPr marL="750504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3pPr>
    <a:lvl4pPr marL="1125756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4pPr>
    <a:lvl5pPr marL="1501008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5pPr>
    <a:lvl6pPr marL="1876260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6pPr>
    <a:lvl7pPr marL="2251513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7pPr>
    <a:lvl8pPr marL="2626764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8pPr>
    <a:lvl9pPr marL="3002016" algn="l" defTabSz="750504" rtl="0" eaLnBrk="1" latinLnBrk="0" hangingPunct="1">
      <a:defRPr sz="98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0658" y="1466606"/>
            <a:ext cx="5674122" cy="3119908"/>
          </a:xfrm>
        </p:spPr>
        <p:txBody>
          <a:bodyPr anchor="b"/>
          <a:lstStyle>
            <a:lvl1pPr algn="ctr">
              <a:defRPr sz="43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4430" y="4706830"/>
            <a:ext cx="5006579" cy="2163606"/>
          </a:xfrm>
        </p:spPr>
        <p:txBody>
          <a:bodyPr/>
          <a:lstStyle>
            <a:lvl1pPr marL="0" indent="0" algn="ctr">
              <a:buNone/>
              <a:defRPr sz="1752"/>
            </a:lvl1pPr>
            <a:lvl2pPr marL="333756" indent="0" algn="ctr">
              <a:buNone/>
              <a:defRPr sz="1460"/>
            </a:lvl2pPr>
            <a:lvl3pPr marL="667512" indent="0" algn="ctr">
              <a:buNone/>
              <a:defRPr sz="1314"/>
            </a:lvl3pPr>
            <a:lvl4pPr marL="1001268" indent="0" algn="ctr">
              <a:buNone/>
              <a:defRPr sz="1168"/>
            </a:lvl4pPr>
            <a:lvl5pPr marL="1335024" indent="0" algn="ctr">
              <a:buNone/>
              <a:defRPr sz="1168"/>
            </a:lvl5pPr>
            <a:lvl6pPr marL="1668780" indent="0" algn="ctr">
              <a:buNone/>
              <a:defRPr sz="1168"/>
            </a:lvl6pPr>
            <a:lvl7pPr marL="2002536" indent="0" algn="ctr">
              <a:buNone/>
              <a:defRPr sz="1168"/>
            </a:lvl7pPr>
            <a:lvl8pPr marL="2336292" indent="0" algn="ctr">
              <a:buNone/>
              <a:defRPr sz="1168"/>
            </a:lvl8pPr>
            <a:lvl9pPr marL="2670048" indent="0" algn="ctr">
              <a:buNone/>
              <a:defRPr sz="1168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6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113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7111" y="477114"/>
            <a:ext cx="1439391" cy="759440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8937" y="477114"/>
            <a:ext cx="4234731" cy="759440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37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222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60" y="2234139"/>
            <a:ext cx="5757565" cy="3727709"/>
          </a:xfrm>
        </p:spPr>
        <p:txBody>
          <a:bodyPr anchor="b"/>
          <a:lstStyle>
            <a:lvl1pPr>
              <a:defRPr sz="43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460" y="5997113"/>
            <a:ext cx="5757565" cy="1960314"/>
          </a:xfrm>
        </p:spPr>
        <p:txBody>
          <a:bodyPr/>
          <a:lstStyle>
            <a:lvl1pPr marL="0" indent="0">
              <a:buNone/>
              <a:defRPr sz="1752">
                <a:solidFill>
                  <a:schemeClr val="tx1"/>
                </a:solidFill>
              </a:defRPr>
            </a:lvl1pPr>
            <a:lvl2pPr marL="333756" indent="0">
              <a:buNone/>
              <a:defRPr sz="1460">
                <a:solidFill>
                  <a:schemeClr val="tx1">
                    <a:tint val="75000"/>
                  </a:schemeClr>
                </a:solidFill>
              </a:defRPr>
            </a:lvl2pPr>
            <a:lvl3pPr marL="667512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3pPr>
            <a:lvl4pPr marL="100126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4pPr>
            <a:lvl5pPr marL="1335024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5pPr>
            <a:lvl6pPr marL="1668780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6pPr>
            <a:lvl7pPr marL="2002536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7pPr>
            <a:lvl8pPr marL="2336292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8pPr>
            <a:lvl9pPr marL="267004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01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8936" y="2385568"/>
            <a:ext cx="2837061" cy="56859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9441" y="2385568"/>
            <a:ext cx="2837061" cy="56859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714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477116"/>
            <a:ext cx="5757565" cy="17321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9806" y="2196797"/>
            <a:ext cx="2824023" cy="1076617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9806" y="3273414"/>
            <a:ext cx="2824023" cy="481469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441" y="2196797"/>
            <a:ext cx="2837931" cy="1076617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441" y="3273414"/>
            <a:ext cx="2837931" cy="481469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48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805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76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97429"/>
            <a:ext cx="2153003" cy="2091002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7931" y="1290283"/>
            <a:ext cx="3379440" cy="6368429"/>
          </a:xfrm>
        </p:spPr>
        <p:txBody>
          <a:bodyPr/>
          <a:lstStyle>
            <a:lvl1pPr>
              <a:defRPr sz="2336"/>
            </a:lvl1pPr>
            <a:lvl2pPr>
              <a:defRPr sz="2044"/>
            </a:lvl2pPr>
            <a:lvl3pPr>
              <a:defRPr sz="1752"/>
            </a:lvl3pPr>
            <a:lvl4pPr>
              <a:defRPr sz="1460"/>
            </a:lvl4pPr>
            <a:lvl5pPr>
              <a:defRPr sz="1460"/>
            </a:lvl5pPr>
            <a:lvl6pPr>
              <a:defRPr sz="1460"/>
            </a:lvl6pPr>
            <a:lvl7pPr>
              <a:defRPr sz="1460"/>
            </a:lvl7pPr>
            <a:lvl8pPr>
              <a:defRPr sz="1460"/>
            </a:lvl8pPr>
            <a:lvl9pPr>
              <a:defRPr sz="146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2688431"/>
            <a:ext cx="2153003" cy="4980652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950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97429"/>
            <a:ext cx="2153003" cy="2091002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7931" y="1290283"/>
            <a:ext cx="3379440" cy="6368429"/>
          </a:xfrm>
        </p:spPr>
        <p:txBody>
          <a:bodyPr anchor="t"/>
          <a:lstStyle>
            <a:lvl1pPr marL="0" indent="0">
              <a:buNone/>
              <a:defRPr sz="2336"/>
            </a:lvl1pPr>
            <a:lvl2pPr marL="333756" indent="0">
              <a:buNone/>
              <a:defRPr sz="2044"/>
            </a:lvl2pPr>
            <a:lvl3pPr marL="667512" indent="0">
              <a:buNone/>
              <a:defRPr sz="1752"/>
            </a:lvl3pPr>
            <a:lvl4pPr marL="1001268" indent="0">
              <a:buNone/>
              <a:defRPr sz="1460"/>
            </a:lvl4pPr>
            <a:lvl5pPr marL="1335024" indent="0">
              <a:buNone/>
              <a:defRPr sz="1460"/>
            </a:lvl5pPr>
            <a:lvl6pPr marL="1668780" indent="0">
              <a:buNone/>
              <a:defRPr sz="1460"/>
            </a:lvl6pPr>
            <a:lvl7pPr marL="2002536" indent="0">
              <a:buNone/>
              <a:defRPr sz="1460"/>
            </a:lvl7pPr>
            <a:lvl8pPr marL="2336292" indent="0">
              <a:buNone/>
              <a:defRPr sz="1460"/>
            </a:lvl8pPr>
            <a:lvl9pPr marL="2670048" indent="0">
              <a:buNone/>
              <a:defRPr sz="146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2688431"/>
            <a:ext cx="2153003" cy="4980652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364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8937" y="477116"/>
            <a:ext cx="5757565" cy="17321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937" y="2385568"/>
            <a:ext cx="5757565" cy="56859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8936" y="8305927"/>
            <a:ext cx="150197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EA4EA-4DCE-402B-8726-02D68EDC39E6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1239" y="8305927"/>
            <a:ext cx="2252960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4528" y="8305927"/>
            <a:ext cx="150197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3AA24-B7C6-409F-BE48-868777222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03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67512" rtl="0" eaLnBrk="1" latinLnBrk="0" hangingPunct="1">
        <a:lnSpc>
          <a:spcPct val="90000"/>
        </a:lnSpc>
        <a:spcBef>
          <a:spcPct val="0"/>
        </a:spcBef>
        <a:buNone/>
        <a:defRPr sz="3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878" indent="-166878" algn="l" defTabSz="667512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044" kern="1200">
          <a:solidFill>
            <a:schemeClr val="tx1"/>
          </a:solidFill>
          <a:latin typeface="+mn-lt"/>
          <a:ea typeface="+mn-ea"/>
          <a:cs typeface="+mn-cs"/>
        </a:defRPr>
      </a:lvl1pPr>
      <a:lvl2pPr marL="50063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752" kern="1200">
          <a:solidFill>
            <a:schemeClr val="tx1"/>
          </a:solidFill>
          <a:latin typeface="+mn-lt"/>
          <a:ea typeface="+mn-ea"/>
          <a:cs typeface="+mn-cs"/>
        </a:defRPr>
      </a:lvl2pPr>
      <a:lvl3pPr marL="83439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3pPr>
      <a:lvl4pPr marL="116814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501902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835658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16941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50317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83692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1pPr>
      <a:lvl2pPr marL="33375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2pPr>
      <a:lvl3pPr marL="66751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3pPr>
      <a:lvl4pPr marL="100126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335024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66878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00253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33629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67004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ounded Rectangle 2"/>
          <p:cNvSpPr/>
          <p:nvPr/>
        </p:nvSpPr>
        <p:spPr>
          <a:xfrm>
            <a:off x="2101217" y="1617057"/>
            <a:ext cx="2941030" cy="490996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1064535"/>
            <a:r>
              <a:rPr lang="en-US" sz="1251" b="1" dirty="0">
                <a:ln w="0"/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Pakistan cohort (n=416)</a:t>
            </a:r>
          </a:p>
        </p:txBody>
      </p:sp>
      <p:sp>
        <p:nvSpPr>
          <p:cNvPr id="4" name="Rounded Rectangle 3"/>
          <p:cNvSpPr/>
          <p:nvPr/>
        </p:nvSpPr>
        <p:spPr bwMode="auto">
          <a:xfrm>
            <a:off x="1192965" y="2729345"/>
            <a:ext cx="2098139" cy="890519"/>
          </a:xfrm>
          <a:prstGeom prst="roundRect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wrap="square" lIns="106453" tIns="53226" rIns="106453" bIns="53226" numCol="1" rtlCol="0" anchor="ctr" anchorCtr="0" compatLnSpc="1">
            <a:prstTxWarp prst="textNoShape">
              <a:avLst/>
            </a:prstTxWarp>
          </a:bodyPr>
          <a:lstStyle/>
          <a:p>
            <a:pPr algn="ctr" defTabSz="1064535"/>
            <a:r>
              <a:rPr lang="en-US" sz="1251" b="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Undernourished children (n=365)</a:t>
            </a:r>
          </a:p>
          <a:p>
            <a:pPr algn="ctr" defTabSz="1064535"/>
            <a:r>
              <a:rPr lang="en-US" sz="125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WHZ &lt; -2</a:t>
            </a:r>
          </a:p>
          <a:p>
            <a:pPr marL="298009" indent="-298009" algn="ctr" defTabSz="1064535">
              <a:buFont typeface="Arial" panose="020B0604020202020204" pitchFamily="34" charset="0"/>
              <a:buChar char="•"/>
            </a:pPr>
            <a:r>
              <a:rPr lang="en-US" sz="125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 Serum</a:t>
            </a:r>
          </a:p>
        </p:txBody>
      </p:sp>
      <p:sp>
        <p:nvSpPr>
          <p:cNvPr id="5" name="Rounded Rectangle 4"/>
          <p:cNvSpPr/>
          <p:nvPr/>
        </p:nvSpPr>
        <p:spPr bwMode="auto">
          <a:xfrm>
            <a:off x="4080788" y="2718265"/>
            <a:ext cx="2085694" cy="899977"/>
          </a:xfrm>
          <a:prstGeom prst="roundRect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vert="horz" wrap="square" lIns="106453" tIns="53226" rIns="106453" bIns="53226" numCol="1" rtlCol="0" anchor="ctr" anchorCtr="0" compatLnSpc="1">
            <a:prstTxWarp prst="textNoShape">
              <a:avLst/>
            </a:prstTxWarp>
          </a:bodyPr>
          <a:lstStyle/>
          <a:p>
            <a:pPr algn="ctr" defTabSz="1064535"/>
            <a:r>
              <a:rPr lang="en-US" sz="1251" b="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Well-nourished control (n=51)</a:t>
            </a:r>
          </a:p>
          <a:p>
            <a:pPr algn="ctr" defTabSz="1064535"/>
            <a:r>
              <a:rPr lang="en-US" sz="125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WHZ &gt; 0 &amp; HAZ &gt; -1</a:t>
            </a:r>
          </a:p>
          <a:p>
            <a:pPr marL="298009" indent="-298009" algn="ctr" defTabSz="1064535">
              <a:buFont typeface="Arial" panose="020B0604020202020204" pitchFamily="34" charset="0"/>
              <a:buChar char="•"/>
            </a:pPr>
            <a:r>
              <a:rPr lang="en-US" sz="125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Serum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1228174" y="5307212"/>
            <a:ext cx="2022603" cy="1427786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51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ponder &amp; received EGD (n=63)</a:t>
            </a:r>
          </a:p>
          <a:p>
            <a:pPr marL="298009" indent="-298009">
              <a:buFont typeface="Arial" panose="020B0604020202020204" pitchFamily="34" charset="0"/>
              <a:buChar char="•"/>
            </a:pPr>
            <a:r>
              <a:rPr lang="en-US" sz="125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  <a:p>
            <a:pPr marL="298009" indent="-298009">
              <a:buFont typeface="Arial" panose="020B0604020202020204" pitchFamily="34" charset="0"/>
              <a:buChar char="•"/>
            </a:pPr>
            <a:r>
              <a:rPr lang="en-US" sz="125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odenal aspirate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2219632" y="2376867"/>
            <a:ext cx="2822616" cy="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5047328" y="2380700"/>
            <a:ext cx="0" cy="3148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>
            <a:stCxn id="3" idx="2"/>
          </p:cNvCxnSpPr>
          <p:nvPr/>
        </p:nvCxnSpPr>
        <p:spPr>
          <a:xfrm>
            <a:off x="3571732" y="2108054"/>
            <a:ext cx="0" cy="2798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841853" y="2149865"/>
            <a:ext cx="2367" cy="4788625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37523" y="1746036"/>
            <a:ext cx="857501" cy="2848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51" b="1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748775" y="2135656"/>
            <a:ext cx="97891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59128" y="1991213"/>
            <a:ext cx="393042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dirty="0"/>
              <a:t>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08073" y="3020544"/>
            <a:ext cx="283684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dirty="0"/>
              <a:t>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37327" y="3545809"/>
            <a:ext cx="343414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dirty="0"/>
              <a:t>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9766" y="4231332"/>
            <a:ext cx="393719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dirty="0"/>
              <a:t>1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34784" y="6592158"/>
            <a:ext cx="393719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dirty="0"/>
              <a:t>24</a:t>
            </a:r>
          </a:p>
        </p:txBody>
      </p:sp>
      <p:sp>
        <p:nvSpPr>
          <p:cNvPr id="19" name="Rounded Rectangle 18"/>
          <p:cNvSpPr/>
          <p:nvPr/>
        </p:nvSpPr>
        <p:spPr bwMode="auto">
          <a:xfrm>
            <a:off x="1112236" y="4123157"/>
            <a:ext cx="2773169" cy="567293"/>
          </a:xfrm>
          <a:prstGeom prst="roundRect">
            <a:avLst/>
          </a:prstGeom>
          <a:ln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wrap="square" lIns="106453" tIns="53226" rIns="106453" bIns="53226" numCol="1" rtlCol="0" anchor="ctr" anchorCtr="0" compatLnSpc="1">
            <a:prstTxWarp prst="textNoShape">
              <a:avLst/>
            </a:prstTxWarp>
          </a:bodyPr>
          <a:lstStyle/>
          <a:p>
            <a:pPr algn="ctr" defTabSz="1064535"/>
            <a:r>
              <a:rPr lang="en-US" sz="1251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tritional intervention </a:t>
            </a:r>
            <a:r>
              <a:rPr lang="en-US" sz="1251" b="1" dirty="0">
                <a:solidFill>
                  <a:schemeClr val="tx1"/>
                </a:solidFill>
                <a:latin typeface="Arial" charset="0"/>
                <a:ea typeface="ＭＳ Ｐゴシック" pitchFamily="-109" charset="-128"/>
              </a:rPr>
              <a:t>(n=189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39476" y="4837050"/>
            <a:ext cx="2157302" cy="2848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51" dirty="0">
                <a:latin typeface="Arial" panose="020B0604020202020204" pitchFamily="34" charset="0"/>
                <a:cs typeface="Arial" panose="020B0604020202020204" pitchFamily="34" charset="0"/>
              </a:rPr>
              <a:t>Not responded (WHZ &lt; -2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33985" y="7557702"/>
            <a:ext cx="5577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. Study design. 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711184" y="3179196"/>
            <a:ext cx="97891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24539" y="3672083"/>
            <a:ext cx="97891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52846" y="4393744"/>
            <a:ext cx="97891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731795" y="6750810"/>
            <a:ext cx="97891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stCxn id="4" idx="2"/>
          </p:cNvCxnSpPr>
          <p:nvPr/>
        </p:nvCxnSpPr>
        <p:spPr>
          <a:xfrm flipH="1">
            <a:off x="2239475" y="3619864"/>
            <a:ext cx="2559" cy="5032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endCxn id="7" idx="0"/>
          </p:cNvCxnSpPr>
          <p:nvPr/>
        </p:nvCxnSpPr>
        <p:spPr>
          <a:xfrm>
            <a:off x="2239475" y="4711050"/>
            <a:ext cx="0" cy="5961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endCxn id="4" idx="0"/>
          </p:cNvCxnSpPr>
          <p:nvPr/>
        </p:nvCxnSpPr>
        <p:spPr>
          <a:xfrm>
            <a:off x="2239475" y="2387920"/>
            <a:ext cx="2559" cy="3414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21722" y="167031"/>
            <a:ext cx="6089919" cy="774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ile acid profiling reveals distinct signatures in undernourished children with environmental enteric </a:t>
            </a:r>
            <a:r>
              <a:rPr lang="en-US" dirty="0" smtClean="0"/>
              <a:t>dysfunction, Xueheng Zhao &amp; Kenneth DR Setchell, Online Supplementary </a:t>
            </a:r>
            <a:r>
              <a:rPr lang="en-US" dirty="0"/>
              <a:t>Materi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3581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436189" y="7157675"/>
            <a:ext cx="6051107" cy="1354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alt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riable importance in </a:t>
            </a:r>
            <a:r>
              <a:rPr lang="en-US" alt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ditional random forest (RF) modeling WHZ and WAZ at 24 months of age using serum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 profile at 9 months.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Variable importance in modelling WHZ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24 months using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rum BAs (%) at 9 months. T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ining dataset (n=277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(B) Variable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portance in modelling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AZ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24 months using serum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 (%)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9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nths. Training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set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277).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0" y="11010900"/>
            <a:ext cx="6675438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kumimoji="0" lang="en-US" altLang="en-US" sz="5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0118" y="39392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70118" y="396324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Chart 10">
            <a:extLst>
              <a:ext uri="{FF2B5EF4-FFF2-40B4-BE49-F238E27FC236}">
                <a16:creationId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:lc="http://schemas.openxmlformats.org/drawingml/2006/lockedCanvas" id="{08C31370-F2A4-4BE2-AEAA-631F53A9C36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59818421"/>
              </p:ext>
            </p:extLst>
          </p:nvPr>
        </p:nvGraphicFramePr>
        <p:xfrm>
          <a:off x="927541" y="84005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:lc="http://schemas.openxmlformats.org/drawingml/2006/lockedCanvas" id="{F44861AC-3A26-4722-9515-8B760810C4E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1976666"/>
              </p:ext>
            </p:extLst>
          </p:nvPr>
        </p:nvGraphicFramePr>
        <p:xfrm>
          <a:off x="1051719" y="429119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63294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p&#10;&#10;Description automatically generated">
            <a:extLst>
              <a:ext uri="{FF2B5EF4-FFF2-40B4-BE49-F238E27FC236}">
                <a16:creationId xmlns:a16="http://schemas.microsoft.com/office/drawing/2014/main" xmlns="" id="{D01A4E0B-7AC4-2840-9608-A9FB132BBA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5121" y="1376910"/>
            <a:ext cx="1827437" cy="209857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494663" y="4621069"/>
            <a:ext cx="60264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uodenal Histolog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eature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kistani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E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ildre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are shown illustrating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th cell density, Brunner gland hyperplasia, and villou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unting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EED children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20D74262-06F5-2945-BCBE-73F0064EEB2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04" t="2855" r="9573"/>
          <a:stretch/>
        </p:blipFill>
        <p:spPr>
          <a:xfrm>
            <a:off x="3389684" y="1440380"/>
            <a:ext cx="1827437" cy="203510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233097" y="3549287"/>
            <a:ext cx="2032404" cy="546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ED with Paneth cell depletion  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646105" y="3549287"/>
            <a:ext cx="1771794" cy="774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ED with Brunner gland </a:t>
            </a:r>
            <a:r>
              <a:rPr lang="en-US" dirty="0"/>
              <a:t>h</a:t>
            </a:r>
            <a:r>
              <a:rPr lang="en-US" dirty="0" smtClean="0"/>
              <a:t>yperplasia</a:t>
            </a:r>
            <a:endParaRPr lang="en-US" dirty="0"/>
          </a:p>
          <a:p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3250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943" y="417105"/>
            <a:ext cx="6051666" cy="678099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4165" y="242506"/>
            <a:ext cx="338554" cy="349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4165" y="3720301"/>
            <a:ext cx="338554" cy="349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459220" y="7198096"/>
            <a:ext cx="6048432" cy="14157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</a:t>
            </a:r>
            <a:r>
              <a:rPr lang="en-US" sz="1200" b="1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. Duodenal aspirate and plasma and BA profiles in Pakistani EED children. 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% Composition of duodenal aspirates BA subspecies in EED children (n=39). (B) % Composition of plasma BA subspecies in EED children (n=55). Subgroups of EED children were determined by the total histological EED index, i.e. below 50</a:t>
            </a:r>
            <a:r>
              <a:rPr lang="en-US" sz="1200" spc="1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ercentile ( EED score ≤ median composite score) and above 50</a:t>
            </a:r>
            <a:r>
              <a:rPr lang="en-US" sz="1200" spc="1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ercentile ( EED score &gt; median composite score). 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 values were calculated with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o-tailed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udent’s 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-test, </a:t>
            </a:r>
            <a:r>
              <a:rPr lang="en-US" sz="14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&lt;0.05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35139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8884" y="1018183"/>
            <a:ext cx="338554" cy="349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48621" y="1018183"/>
            <a:ext cx="338554" cy="349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266027" y="5722845"/>
            <a:ext cx="614338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</a:t>
            </a:r>
            <a:r>
              <a:rPr lang="en-US" sz="1200" b="1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. Secondary BA (%) and plasma sterol-C4 in Pakistani EED children. 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Profile of secondary BA in plasma and duodenal aspirates of EED children (plasma n=55, duodenal aspirate n=39).  (B) Profile of plasma sterol-C4 in EED children (n=55). B</a:t>
            </a:r>
            <a:r>
              <a:rPr lang="en-US" sz="1200" dirty="0">
                <a:solidFill>
                  <a:srgbClr val="202124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x-and-whisker plot showed median and interquartile range (IQR) of data.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bgroups of EED children were determined by the histological EED index, i.e. below 50</a:t>
            </a:r>
            <a:r>
              <a:rPr lang="en-US" sz="1200" spc="1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ercentile (EED score ≤ median composite score) and above 50</a:t>
            </a:r>
            <a:r>
              <a:rPr lang="en-US" sz="1200" spc="1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ercentile (EED score &gt; median composite score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Two-tailed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udent’s t-test, ns 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&gt;0.05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11925"/>
            <a:ext cx="6675438" cy="4066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97896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4125" y="5162889"/>
            <a:ext cx="3952381" cy="172381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6062" y="7860769"/>
            <a:ext cx="61433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6. Total BAs and hydrophobicit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dex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 duodenal aspirate and plasma and correlation to feca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alorimetry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Hydrophobicity index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sma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5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duodenal aspirat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n=39) in EED children,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s </a:t>
            </a:r>
            <a:r>
              <a:rPr lang="en-US" sz="1200" spc="1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&gt;0.05 </a:t>
            </a:r>
            <a:r>
              <a:rPr lang="en-US" sz="1200" spc="1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wo-tailed Student’s t-tes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pearman correlation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 biomarker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%) and hydrophobicity index in plasma (n=52)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duoden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pirat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n=32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EED children to fecal calorimetry values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88608" y="3850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8608" y="496820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 rot="-2700000">
            <a:off x="1964023" y="6877381"/>
            <a:ext cx="972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CA (%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-2700000">
            <a:off x="1977397" y="6973494"/>
            <a:ext cx="1882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condary BA (%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-2700000">
            <a:off x="2567979" y="7102677"/>
            <a:ext cx="1882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ydrophobicity index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75436"/>
            <a:ext cx="6675438" cy="3909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0963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781</TotalTime>
  <Words>454</Words>
  <Application>Microsoft Office PowerPoint</Application>
  <PresentationFormat>Custom</PresentationFormat>
  <Paragraphs>4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ＭＳ Ｐゴシック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incinnati Children's Hospit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o, Xueheng</dc:creator>
  <cp:lastModifiedBy>Zhao, Xueheng</cp:lastModifiedBy>
  <cp:revision>632</cp:revision>
  <cp:lastPrinted>2020-09-01T20:18:26Z</cp:lastPrinted>
  <dcterms:created xsi:type="dcterms:W3CDTF">2020-04-20T01:03:07Z</dcterms:created>
  <dcterms:modified xsi:type="dcterms:W3CDTF">2021-08-20T13:23:51Z</dcterms:modified>
</cp:coreProperties>
</file>